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463" r:id="rId2"/>
    <p:sldId id="464" r:id="rId3"/>
    <p:sldId id="375" r:id="rId4"/>
    <p:sldId id="376" r:id="rId5"/>
    <p:sldId id="343" r:id="rId6"/>
    <p:sldId id="424" r:id="rId7"/>
    <p:sldId id="462" r:id="rId8"/>
    <p:sldId id="466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478"/>
    <p:restoredTop sz="94728"/>
  </p:normalViewPr>
  <p:slideViewPr>
    <p:cSldViewPr snapToGrid="0">
      <p:cViewPr varScale="1">
        <p:scale>
          <a:sx n="92" d="100"/>
          <a:sy n="92" d="100"/>
        </p:scale>
        <p:origin x="184" y="3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8B7D64-C89D-C240-8A07-1243D9B80339}" type="datetimeFigureOut">
              <a:rPr lang="en-US" smtClean="0"/>
              <a:t>9/16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383CB1-9F3D-2446-B1BA-8674AC4F64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1500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/>
              <a:t>Fig. 7. Relation between total </a:t>
            </a: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-galactosidase A protein by western blot and α-galactosidase A activity. </a:t>
            </a:r>
            <a:endParaRPr lang="en-GB" sz="1200" b="1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D8A3CF-E4B5-4B6F-8172-550A09ED7740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53130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E80AEB-EA6A-2C39-95CE-E7CB721E183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FE07FB5-6743-A91D-9A77-C85D2D51B3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539CE9-2D28-63F0-FF05-F630302E8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AF6DE-9361-CE40-96FB-72461DD5DB15}" type="datetimeFigureOut">
              <a:rPr lang="en-US" smtClean="0"/>
              <a:t>9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D17B43-BDC4-F745-58FC-055C6B1B02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2D6165-7281-763F-7CB7-5576A98745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2DF1B-E05C-4A4E-AD34-E4F0073676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835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85520E-DAFA-5020-FAAD-E773E62A19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164439-ADAB-A862-2155-D1AFE6CC96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95A605-E6B1-F194-5A2D-74A40C3C6B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AF6DE-9361-CE40-96FB-72461DD5DB15}" type="datetimeFigureOut">
              <a:rPr lang="en-US" smtClean="0"/>
              <a:t>9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85F03E-FC4C-0B8B-7759-3C52C55E1C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0E43C3-AF7C-86D8-DA22-928FA6D25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2DF1B-E05C-4A4E-AD34-E4F0073676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179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D45783F-1120-5F77-87E9-3EE0F467D1B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98E60B-94BC-0B91-5475-316CF60A61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F9A923-4B53-5154-2196-2EBEC393A4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AF6DE-9361-CE40-96FB-72461DD5DB15}" type="datetimeFigureOut">
              <a:rPr lang="en-US" smtClean="0"/>
              <a:t>9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892101-361A-9201-383D-DAFCD7693F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97F48-F026-4A53-A239-F202CBE39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2DF1B-E05C-4A4E-AD34-E4F0073676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0673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C73F42-FF57-5A9F-17D6-22598D9B7C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51722A-8EA9-5D4C-15DC-64F9812CC5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094571-1899-3D1B-42B4-576A204E8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AF6DE-9361-CE40-96FB-72461DD5DB15}" type="datetimeFigureOut">
              <a:rPr lang="en-US" smtClean="0"/>
              <a:t>9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8875DC-F8F6-202D-7DE0-7E725118CF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AD9666-6B85-67A1-82BE-1D73063060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2DF1B-E05C-4A4E-AD34-E4F0073676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990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60F81C-6BD0-E291-20F7-A5FA06047A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29FCFA-3148-04A9-0D36-605E3354CF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DEE82D-C68B-5C9C-DB9E-5B06357289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AF6DE-9361-CE40-96FB-72461DD5DB15}" type="datetimeFigureOut">
              <a:rPr lang="en-US" smtClean="0"/>
              <a:t>9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296B18-D59F-1674-0C3E-4E8AF42A3F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22688D-3F45-F916-2AF3-56783DDD0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2DF1B-E05C-4A4E-AD34-E4F0073676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6572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F72149-C4A5-FB77-6BA6-A5CAC94ECC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E12E90-2B86-64EC-44B8-3D764188D8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C1E10B1-4E2D-BC3E-F5F4-B47CCEC415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D44B60-377A-C1E8-8F7E-42E50BCBD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AF6DE-9361-CE40-96FB-72461DD5DB15}" type="datetimeFigureOut">
              <a:rPr lang="en-US" smtClean="0"/>
              <a:t>9/1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73AAEA-E53E-0579-E4E3-ED57554B30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6AF7BA-EFCD-7F17-4112-319571C4A1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2DF1B-E05C-4A4E-AD34-E4F0073676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2539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9D76A9-6CCB-12A7-FBBB-7D622FC8FE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11C62B-1C23-1567-723E-F62B8CBD8F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066066A-DC10-3DCF-1E1C-536F2C8C27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03DAB21-0C2B-DA73-6E1B-287543D874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46CF7AF-CC84-292B-78B9-69110C3D50E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028FBFB-B9D8-236F-2DFF-AEC5CFED23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AF6DE-9361-CE40-96FB-72461DD5DB15}" type="datetimeFigureOut">
              <a:rPr lang="en-US" smtClean="0"/>
              <a:t>9/16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97A4C12-B4F6-0CBC-857A-38F5BE998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B80D7E8-C7FD-7BE3-0666-877C2CC4C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2DF1B-E05C-4A4E-AD34-E4F0073676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09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C045A8-0578-E0A9-0A9D-736618C50D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C973C40-02AC-6807-C757-8C00805CC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AF6DE-9361-CE40-96FB-72461DD5DB15}" type="datetimeFigureOut">
              <a:rPr lang="en-US" smtClean="0"/>
              <a:t>9/16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8B16862-03F7-8C60-F659-F23FA86E5E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C1B7833-D233-B1E4-D76D-36ADB1D46C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2DF1B-E05C-4A4E-AD34-E4F0073676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1095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912A3D-F9A7-CEB3-E723-9BC82B9AC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AF6DE-9361-CE40-96FB-72461DD5DB15}" type="datetimeFigureOut">
              <a:rPr lang="en-US" smtClean="0"/>
              <a:t>9/16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42B8032-BC7A-E2FE-BED4-B08F0C29FE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E453D4B-890A-5C41-1A64-3E57DB2303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2DF1B-E05C-4A4E-AD34-E4F0073676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967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95E964-1B25-71E6-E128-87D95BE176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A54B7E-B95E-B949-BE5E-8FB50298DE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189D35-F1D7-D57A-8B13-7594190E8C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5D47E7-DD9A-39B1-A56C-1706A8ACE5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AF6DE-9361-CE40-96FB-72461DD5DB15}" type="datetimeFigureOut">
              <a:rPr lang="en-US" smtClean="0"/>
              <a:t>9/1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F88D69-8893-3183-8BF0-5F03C74FE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A0483F-A2AA-4CB5-598C-35A7957A16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2DF1B-E05C-4A4E-AD34-E4F0073676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516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45A68-8AB6-BD9F-41B5-0F9CA16BD2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D638973-B30E-2723-C4A1-4D15CF4693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4C90CD-B349-2A8B-AC75-3A442B972C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B235D6-8F89-FB0B-6056-CA8BB0FF6A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AF6DE-9361-CE40-96FB-72461DD5DB15}" type="datetimeFigureOut">
              <a:rPr lang="en-US" smtClean="0"/>
              <a:t>9/1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3B83DD-A05C-5BE5-C058-8DA8AD783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2036F1-50A0-8BDA-5E0C-2D43754F4C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2DF1B-E05C-4A4E-AD34-E4F0073676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227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2DEC8C9-E52F-2825-84E3-BD856A956C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CCC761-0CF2-4191-FC12-21824386EE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A40633-C320-C190-7778-B4F525BFBF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48AF6DE-9361-CE40-96FB-72461DD5DB15}" type="datetimeFigureOut">
              <a:rPr lang="en-US" smtClean="0"/>
              <a:t>9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447C9B-A1B9-ACB6-2DCB-B9B128C6A9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9BF58A-1CFF-2B46-FB8B-4C790ACB2F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AF2DF1B-E05C-4A4E-AD34-E4F0073676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0480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5.emf"/><Relationship Id="rId4" Type="http://schemas.openxmlformats.org/officeDocument/2006/relationships/image" Target="../media/image12.emf"/><Relationship Id="rId9" Type="http://schemas.openxmlformats.org/officeDocument/2006/relationships/oleObject" Target="../embeddings/oleObject4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9.bin"/><Relationship Id="rId13" Type="http://schemas.openxmlformats.org/officeDocument/2006/relationships/image" Target="../media/image22.emf"/><Relationship Id="rId3" Type="http://schemas.openxmlformats.org/officeDocument/2006/relationships/image" Target="../media/image17.emf"/><Relationship Id="rId7" Type="http://schemas.openxmlformats.org/officeDocument/2006/relationships/image" Target="../media/image19.emf"/><Relationship Id="rId12" Type="http://schemas.openxmlformats.org/officeDocument/2006/relationships/oleObject" Target="../embeddings/oleObject11.bin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8.bin"/><Relationship Id="rId11" Type="http://schemas.openxmlformats.org/officeDocument/2006/relationships/image" Target="../media/image21.emf"/><Relationship Id="rId5" Type="http://schemas.openxmlformats.org/officeDocument/2006/relationships/image" Target="../media/image18.emf"/><Relationship Id="rId10" Type="http://schemas.openxmlformats.org/officeDocument/2006/relationships/oleObject" Target="../embeddings/oleObject10.bin"/><Relationship Id="rId4" Type="http://schemas.openxmlformats.org/officeDocument/2006/relationships/oleObject" Target="../embeddings/oleObject7.bin"/><Relationship Id="rId9" Type="http://schemas.openxmlformats.org/officeDocument/2006/relationships/image" Target="../media/image20.em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0000000-0008-0000-0800-000002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6837" t="22225" r="12894" b="49299"/>
          <a:stretch/>
        </p:blipFill>
        <p:spPr>
          <a:xfrm>
            <a:off x="246587" y="174920"/>
            <a:ext cx="3678231" cy="2928937"/>
          </a:xfrm>
          <a:prstGeom prst="rect">
            <a:avLst/>
          </a:prstGeom>
        </p:spPr>
      </p:pic>
      <p:sp>
        <p:nvSpPr>
          <p:cNvPr id="5" name="TextBox 40">
            <a:extLst>
              <a:ext uri="{FF2B5EF4-FFF2-40B4-BE49-F238E27FC236}">
                <a16:creationId xmlns:a16="http://schemas.microsoft.com/office/drawing/2014/main" id="{00000000-0008-0000-0800-000003000000}"/>
              </a:ext>
            </a:extLst>
          </p:cNvPr>
          <p:cNvSpPr txBox="1"/>
          <p:nvPr/>
        </p:nvSpPr>
        <p:spPr>
          <a:xfrm>
            <a:off x="910144" y="589050"/>
            <a:ext cx="2613264" cy="19774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>
                <a:solidFill>
                  <a:sysClr val="windowText" lastClr="000000"/>
                </a:solidFill>
              </a:rPr>
              <a:t>                        Ken         38           36           34         33        32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0000000-0008-0000-0700-000002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9403" t="28938" r="11097" b="44901"/>
          <a:stretch/>
        </p:blipFill>
        <p:spPr>
          <a:xfrm>
            <a:off x="4031339" y="413044"/>
            <a:ext cx="3554557" cy="2690813"/>
          </a:xfrm>
          <a:prstGeom prst="rect">
            <a:avLst/>
          </a:prstGeom>
        </p:spPr>
      </p:pic>
      <p:sp>
        <p:nvSpPr>
          <p:cNvPr id="7" name="TextBox 40">
            <a:extLst>
              <a:ext uri="{FF2B5EF4-FFF2-40B4-BE49-F238E27FC236}">
                <a16:creationId xmlns:a16="http://schemas.microsoft.com/office/drawing/2014/main" id="{00000000-0008-0000-0700-000003000000}"/>
              </a:ext>
            </a:extLst>
          </p:cNvPr>
          <p:cNvSpPr txBox="1"/>
          <p:nvPr/>
        </p:nvSpPr>
        <p:spPr>
          <a:xfrm>
            <a:off x="4298039" y="784519"/>
            <a:ext cx="2930669" cy="17621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>
                <a:solidFill>
                  <a:sysClr val="windowText" lastClr="000000"/>
                </a:solidFill>
              </a:rPr>
              <a:t>                    Sandy         1           7</a:t>
            </a:r>
            <a:r>
              <a:rPr lang="en-GB" sz="800" b="1" baseline="0">
                <a:solidFill>
                  <a:sysClr val="windowText" lastClr="000000"/>
                </a:solidFill>
              </a:rPr>
              <a:t>          21         29</a:t>
            </a:r>
            <a:r>
              <a:rPr lang="en-GB" sz="800" b="1">
                <a:solidFill>
                  <a:sysClr val="windowText" lastClr="000000"/>
                </a:solidFill>
              </a:rPr>
              <a:t>          30         38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0000000-0008-0000-0600-000002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4400" t="24308" r="11996" b="46521"/>
          <a:stretch/>
        </p:blipFill>
        <p:spPr>
          <a:xfrm>
            <a:off x="7692417" y="174920"/>
            <a:ext cx="4290580" cy="3000375"/>
          </a:xfrm>
          <a:prstGeom prst="rect">
            <a:avLst/>
          </a:prstGeom>
        </p:spPr>
      </p:pic>
      <p:sp>
        <p:nvSpPr>
          <p:cNvPr id="9" name="TextBox 40">
            <a:extLst>
              <a:ext uri="{FF2B5EF4-FFF2-40B4-BE49-F238E27FC236}">
                <a16:creationId xmlns:a16="http://schemas.microsoft.com/office/drawing/2014/main" id="{00000000-0008-0000-0600-000003000000}"/>
              </a:ext>
            </a:extLst>
          </p:cNvPr>
          <p:cNvSpPr txBox="1"/>
          <p:nvPr/>
        </p:nvSpPr>
        <p:spPr>
          <a:xfrm>
            <a:off x="7872009" y="555920"/>
            <a:ext cx="3458561" cy="19750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>
                <a:solidFill>
                  <a:sysClr val="windowText" lastClr="000000"/>
                </a:solidFill>
              </a:rPr>
              <a:t>            HC           29           1             7             36            34          33         32            27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00000000-0008-0000-0500-000002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1051" t="20744" r="9572" b="53327"/>
          <a:stretch/>
        </p:blipFill>
        <p:spPr>
          <a:xfrm>
            <a:off x="246587" y="3601950"/>
            <a:ext cx="3568700" cy="2667000"/>
          </a:xfrm>
          <a:prstGeom prst="rect">
            <a:avLst/>
          </a:prstGeom>
        </p:spPr>
      </p:pic>
      <p:sp>
        <p:nvSpPr>
          <p:cNvPr id="11" name="TextBox 40">
            <a:extLst>
              <a:ext uri="{FF2B5EF4-FFF2-40B4-BE49-F238E27FC236}">
                <a16:creationId xmlns:a16="http://schemas.microsoft.com/office/drawing/2014/main" id="{00000000-0008-0000-0500-000003000000}"/>
              </a:ext>
            </a:extLst>
          </p:cNvPr>
          <p:cNvSpPr txBox="1"/>
          <p:nvPr/>
        </p:nvSpPr>
        <p:spPr>
          <a:xfrm>
            <a:off x="822320" y="4068675"/>
            <a:ext cx="2564667" cy="217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>
                <a:solidFill>
                  <a:sysClr val="windowText" lastClr="000000"/>
                </a:solidFill>
              </a:rPr>
              <a:t>                    Sandy       36       </a:t>
            </a:r>
            <a:r>
              <a:rPr lang="en-GB" sz="800" b="1" baseline="0">
                <a:solidFill>
                  <a:sysClr val="windowText" lastClr="000000"/>
                </a:solidFill>
              </a:rPr>
              <a:t> 34          33         32</a:t>
            </a:r>
            <a:r>
              <a:rPr lang="en-GB" sz="800" b="1">
                <a:solidFill>
                  <a:sysClr val="windowText" lastClr="000000"/>
                </a:solidFill>
              </a:rPr>
              <a:t>          27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00000000-0008-0000-0400-000002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2925" t="34819" r="19573" b="40363"/>
          <a:stretch/>
        </p:blipFill>
        <p:spPr>
          <a:xfrm>
            <a:off x="4031339" y="3659100"/>
            <a:ext cx="3214007" cy="2552700"/>
          </a:xfrm>
          <a:prstGeom prst="rect">
            <a:avLst/>
          </a:prstGeom>
        </p:spPr>
      </p:pic>
      <p:sp>
        <p:nvSpPr>
          <p:cNvPr id="12" name="TextBox 40">
            <a:extLst>
              <a:ext uri="{FF2B5EF4-FFF2-40B4-BE49-F238E27FC236}">
                <a16:creationId xmlns:a16="http://schemas.microsoft.com/office/drawing/2014/main" id="{00000000-0008-0000-0400-000003000000}"/>
              </a:ext>
            </a:extLst>
          </p:cNvPr>
          <p:cNvSpPr txBox="1"/>
          <p:nvPr/>
        </p:nvSpPr>
        <p:spPr>
          <a:xfrm>
            <a:off x="4352099" y="3777686"/>
            <a:ext cx="2572485" cy="217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solidFill>
                  <a:srgbClr val="FFC000"/>
                </a:solidFill>
              </a:rPr>
              <a:t>         </a:t>
            </a:r>
            <a:r>
              <a:rPr lang="en-GB" sz="800" b="1" dirty="0">
                <a:solidFill>
                  <a:sysClr val="windowText" lastClr="000000"/>
                </a:solidFill>
              </a:rPr>
              <a:t>CTRL*     CHQ     DGJ        30         29       27         HC*   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00000000-0008-0000-0300-000002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74150" t="26392" r="13663" b="45364"/>
          <a:stretch/>
        </p:blipFill>
        <p:spPr>
          <a:xfrm>
            <a:off x="7613865" y="3482887"/>
            <a:ext cx="2245154" cy="2905126"/>
          </a:xfrm>
          <a:prstGeom prst="rect">
            <a:avLst/>
          </a:prstGeom>
        </p:spPr>
      </p:pic>
      <p:sp>
        <p:nvSpPr>
          <p:cNvPr id="14" name="TextBox 40">
            <a:extLst>
              <a:ext uri="{FF2B5EF4-FFF2-40B4-BE49-F238E27FC236}">
                <a16:creationId xmlns:a16="http://schemas.microsoft.com/office/drawing/2014/main" id="{00000000-0008-0000-0300-000003000000}"/>
              </a:ext>
            </a:extLst>
          </p:cNvPr>
          <p:cNvSpPr txBox="1"/>
          <p:nvPr/>
        </p:nvSpPr>
        <p:spPr>
          <a:xfrm>
            <a:off x="8155101" y="3928572"/>
            <a:ext cx="2072437" cy="28020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/>
              <a:t>           </a:t>
            </a:r>
            <a:r>
              <a:rPr lang="en-GB" sz="900" b="1"/>
              <a:t>HC        21        2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5479572-E23F-7A18-7B37-FBFF291ECF55}"/>
              </a:ext>
            </a:extLst>
          </p:cNvPr>
          <p:cNvSpPr txBox="1"/>
          <p:nvPr/>
        </p:nvSpPr>
        <p:spPr>
          <a:xfrm>
            <a:off x="1337513" y="6464451"/>
            <a:ext cx="9693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1A. Whole blots corresponding to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Galactosidase A quantification by WB</a:t>
            </a:r>
            <a:r>
              <a:rPr lang="en-GB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6888365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16E9718D-2AB9-89AD-7A09-B0CDA7FB4834}"/>
              </a:ext>
            </a:extLst>
          </p:cNvPr>
          <p:cNvGrpSpPr/>
          <p:nvPr/>
        </p:nvGrpSpPr>
        <p:grpSpPr>
          <a:xfrm>
            <a:off x="334847" y="269354"/>
            <a:ext cx="4046340" cy="2452687"/>
            <a:chOff x="4371270" y="2202656"/>
            <a:chExt cx="4046340" cy="2452687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D6C356BC-31D1-FA4E-74F0-BA52914BD5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9140" t="22225" r="22002" b="53929"/>
            <a:stretch/>
          </p:blipFill>
          <p:spPr>
            <a:xfrm>
              <a:off x="4371270" y="2202656"/>
              <a:ext cx="3449459" cy="2452687"/>
            </a:xfrm>
            <a:prstGeom prst="rect">
              <a:avLst/>
            </a:prstGeom>
          </p:spPr>
        </p:pic>
        <p:sp>
          <p:nvSpPr>
            <p:cNvPr id="4" name="TextBox 85">
              <a:extLst>
                <a:ext uri="{FF2B5EF4-FFF2-40B4-BE49-F238E27FC236}">
                  <a16:creationId xmlns:a16="http://schemas.microsoft.com/office/drawing/2014/main" id="{553907B4-E7F5-6BE1-7034-88CEF52D784F}"/>
                </a:ext>
              </a:extLst>
            </p:cNvPr>
            <p:cNvSpPr txBox="1"/>
            <p:nvPr/>
          </p:nvSpPr>
          <p:spPr>
            <a:xfrm>
              <a:off x="6367665" y="2382657"/>
              <a:ext cx="2049945" cy="23320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900" b="1" dirty="0"/>
                <a:t>N215S  P205T</a:t>
              </a:r>
              <a:r>
                <a:rPr lang="en-GB" sz="900" b="1" baseline="0" dirty="0"/>
                <a:t>  </a:t>
              </a:r>
              <a:r>
                <a:rPr lang="en-GB" sz="900" b="1" dirty="0"/>
                <a:t>HC</a:t>
              </a:r>
            </a:p>
          </p:txBody>
        </p:sp>
        <p:sp>
          <p:nvSpPr>
            <p:cNvPr id="5" name="TextBox 90">
              <a:extLst>
                <a:ext uri="{FF2B5EF4-FFF2-40B4-BE49-F238E27FC236}">
                  <a16:creationId xmlns:a16="http://schemas.microsoft.com/office/drawing/2014/main" id="{EA9B67AB-FCED-384F-D393-764F330140B9}"/>
                </a:ext>
              </a:extLst>
            </p:cNvPr>
            <p:cNvSpPr txBox="1"/>
            <p:nvPr/>
          </p:nvSpPr>
          <p:spPr>
            <a:xfrm>
              <a:off x="6755906" y="2207586"/>
              <a:ext cx="261703" cy="2769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b="1">
                  <a:solidFill>
                    <a:srgbClr val="0070C0"/>
                  </a:solidFill>
                </a:rPr>
                <a:t>5</a:t>
              </a:r>
            </a:p>
          </p:txBody>
        </p:sp>
        <p:sp>
          <p:nvSpPr>
            <p:cNvPr id="6" name="TextBox 91">
              <a:extLst>
                <a:ext uri="{FF2B5EF4-FFF2-40B4-BE49-F238E27FC236}">
                  <a16:creationId xmlns:a16="http://schemas.microsoft.com/office/drawing/2014/main" id="{5DF0D2DD-5C21-F5CD-C750-E661A125DC0F}"/>
                </a:ext>
              </a:extLst>
            </p:cNvPr>
            <p:cNvSpPr txBox="1"/>
            <p:nvPr/>
          </p:nvSpPr>
          <p:spPr>
            <a:xfrm>
              <a:off x="6403080" y="2202656"/>
              <a:ext cx="339798" cy="2769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b="1">
                  <a:solidFill>
                    <a:srgbClr val="0070C0"/>
                  </a:solidFill>
                </a:rPr>
                <a:t>17</a:t>
              </a:r>
            </a:p>
          </p:txBody>
        </p:sp>
      </p:grp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C0E8DF33-CF8D-445E-CB45-F2A1E59F1DF9}"/>
              </a:ext>
            </a:extLst>
          </p:cNvPr>
          <p:cNvCxnSpPr/>
          <p:nvPr/>
        </p:nvCxnSpPr>
        <p:spPr>
          <a:xfrm>
            <a:off x="666206" y="914400"/>
            <a:ext cx="144997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5A951705-7F50-D947-C7AE-45C8A3B8AEC4}"/>
              </a:ext>
            </a:extLst>
          </p:cNvPr>
          <p:cNvSpPr txBox="1"/>
          <p:nvPr/>
        </p:nvSpPr>
        <p:spPr>
          <a:xfrm>
            <a:off x="529892" y="269354"/>
            <a:ext cx="17226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Serial dilutions of recombinant enzyme </a:t>
            </a:r>
            <a:r>
              <a:rPr lang="en-GB" sz="900" i="0" u="none" strike="noStrike" baseline="0" dirty="0" err="1">
                <a:solidFill>
                  <a:srgbClr val="000000"/>
                </a:solidFill>
                <a:latin typeface="Calibri" panose="020F0502020204030204" pitchFamily="34" charset="0"/>
              </a:rPr>
              <a:t>algasidase</a:t>
            </a:r>
            <a:r>
              <a:rPr lang="en-GB" sz="90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 alfa 1 mg/ml, used for Enzyme Replacement Therapy, </a:t>
            </a:r>
            <a:r>
              <a:rPr lang="en-GB" sz="900" i="0" u="none" strike="noStrike" baseline="0" dirty="0" err="1">
                <a:solidFill>
                  <a:srgbClr val="000000"/>
                </a:solidFill>
                <a:latin typeface="Calibri" panose="020F0502020204030204" pitchFamily="34" charset="0"/>
              </a:rPr>
              <a:t>Replagal</a:t>
            </a:r>
            <a:r>
              <a:rPr lang="en-GB" sz="90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® Takeda</a:t>
            </a:r>
            <a:endParaRPr lang="en-GB" sz="900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00000000-0008-0000-0100-000002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0815" t="34263" r="16742" b="45595"/>
          <a:stretch/>
        </p:blipFill>
        <p:spPr>
          <a:xfrm flipH="1">
            <a:off x="4083828" y="98187"/>
            <a:ext cx="2889574" cy="2651315"/>
          </a:xfrm>
          <a:prstGeom prst="rect">
            <a:avLst/>
          </a:prstGeom>
        </p:spPr>
      </p:pic>
      <p:grpSp>
        <p:nvGrpSpPr>
          <p:cNvPr id="13" name="Group 12">
            <a:extLst>
              <a:ext uri="{FF2B5EF4-FFF2-40B4-BE49-F238E27FC236}">
                <a16:creationId xmlns:a16="http://schemas.microsoft.com/office/drawing/2014/main" id="{00000000-0008-0000-0100-000008000000}"/>
              </a:ext>
            </a:extLst>
          </p:cNvPr>
          <p:cNvGrpSpPr/>
          <p:nvPr/>
        </p:nvGrpSpPr>
        <p:grpSpPr>
          <a:xfrm>
            <a:off x="4551605" y="143893"/>
            <a:ext cx="2421798" cy="513589"/>
            <a:chOff x="672197" y="55945"/>
            <a:chExt cx="3352088" cy="433809"/>
          </a:xfrm>
        </p:grpSpPr>
        <p:sp>
          <p:nvSpPr>
            <p:cNvPr id="14" name="TextBox 62">
              <a:extLst>
                <a:ext uri="{FF2B5EF4-FFF2-40B4-BE49-F238E27FC236}">
                  <a16:creationId xmlns:a16="http://schemas.microsoft.com/office/drawing/2014/main" id="{00000000-0008-0000-0100-000009000000}"/>
                </a:ext>
              </a:extLst>
            </p:cNvPr>
            <p:cNvSpPr txBox="1"/>
            <p:nvPr/>
          </p:nvSpPr>
          <p:spPr>
            <a:xfrm flipH="1">
              <a:off x="672197" y="255784"/>
              <a:ext cx="3352088" cy="2339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b="1" dirty="0"/>
                <a:t>      </a:t>
              </a:r>
              <a:r>
                <a:rPr lang="en-GB" sz="900" b="1" dirty="0"/>
                <a:t>HC       DGJ      CHQ    G208H   R342X</a:t>
              </a:r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00000000-0008-0000-0100-00000A000000}"/>
                </a:ext>
              </a:extLst>
            </p:cNvPr>
            <p:cNvGrpSpPr/>
            <p:nvPr/>
          </p:nvGrpSpPr>
          <p:grpSpPr>
            <a:xfrm>
              <a:off x="2385860" y="55945"/>
              <a:ext cx="769512" cy="276999"/>
              <a:chOff x="2385860" y="55945"/>
              <a:chExt cx="769512" cy="276999"/>
            </a:xfrm>
          </p:grpSpPr>
          <p:sp>
            <p:nvSpPr>
              <p:cNvPr id="16" name="TextBox 76">
                <a:extLst>
                  <a:ext uri="{FF2B5EF4-FFF2-40B4-BE49-F238E27FC236}">
                    <a16:creationId xmlns:a16="http://schemas.microsoft.com/office/drawing/2014/main" id="{00000000-0008-0000-0100-00000B000000}"/>
                  </a:ext>
                </a:extLst>
              </p:cNvPr>
              <p:cNvSpPr txBox="1"/>
              <p:nvPr/>
            </p:nvSpPr>
            <p:spPr>
              <a:xfrm>
                <a:off x="2385860" y="55945"/>
                <a:ext cx="27041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200" b="1">
                    <a:solidFill>
                      <a:srgbClr val="0070C0"/>
                    </a:solidFill>
                  </a:rPr>
                  <a:t>1</a:t>
                </a:r>
              </a:p>
            </p:txBody>
          </p:sp>
          <p:sp>
            <p:nvSpPr>
              <p:cNvPr id="17" name="TextBox 89">
                <a:extLst>
                  <a:ext uri="{FF2B5EF4-FFF2-40B4-BE49-F238E27FC236}">
                    <a16:creationId xmlns:a16="http://schemas.microsoft.com/office/drawing/2014/main" id="{00000000-0008-0000-0100-00000C000000}"/>
                  </a:ext>
                </a:extLst>
              </p:cNvPr>
              <p:cNvSpPr txBox="1"/>
              <p:nvPr/>
            </p:nvSpPr>
            <p:spPr>
              <a:xfrm>
                <a:off x="2892159" y="55945"/>
                <a:ext cx="2632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200" b="1" dirty="0">
                    <a:solidFill>
                      <a:srgbClr val="0070C0"/>
                    </a:solidFill>
                  </a:rPr>
                  <a:t>7</a:t>
                </a:r>
              </a:p>
            </p:txBody>
          </p:sp>
        </p:grpSp>
      </p:grpSp>
      <p:pic>
        <p:nvPicPr>
          <p:cNvPr id="18" name="Picture 17">
            <a:extLst>
              <a:ext uri="{FF2B5EF4-FFF2-40B4-BE49-F238E27FC236}">
                <a16:creationId xmlns:a16="http://schemas.microsoft.com/office/drawing/2014/main" id="{00000000-0008-0000-0000-000004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7338" t="40283" r="56672" b="36566"/>
          <a:stretch/>
        </p:blipFill>
        <p:spPr>
          <a:xfrm>
            <a:off x="7520657" y="143893"/>
            <a:ext cx="3418822" cy="2806496"/>
          </a:xfrm>
          <a:prstGeom prst="rect">
            <a:avLst/>
          </a:prstGeom>
        </p:spPr>
      </p:pic>
      <p:grpSp>
        <p:nvGrpSpPr>
          <p:cNvPr id="19" name="Group 18">
            <a:extLst>
              <a:ext uri="{FF2B5EF4-FFF2-40B4-BE49-F238E27FC236}">
                <a16:creationId xmlns:a16="http://schemas.microsoft.com/office/drawing/2014/main" id="{00000000-0008-0000-0000-00000A000000}"/>
              </a:ext>
            </a:extLst>
          </p:cNvPr>
          <p:cNvGrpSpPr/>
          <p:nvPr/>
        </p:nvGrpSpPr>
        <p:grpSpPr>
          <a:xfrm>
            <a:off x="7868214" y="92273"/>
            <a:ext cx="3914257" cy="565209"/>
            <a:chOff x="2840275" y="-32145"/>
            <a:chExt cx="3352088" cy="507636"/>
          </a:xfrm>
        </p:grpSpPr>
        <p:sp>
          <p:nvSpPr>
            <p:cNvPr id="20" name="TextBox 62">
              <a:extLst>
                <a:ext uri="{FF2B5EF4-FFF2-40B4-BE49-F238E27FC236}">
                  <a16:creationId xmlns:a16="http://schemas.microsoft.com/office/drawing/2014/main" id="{00000000-0008-0000-0000-000005000000}"/>
                </a:ext>
              </a:extLst>
            </p:cNvPr>
            <p:cNvSpPr txBox="1"/>
            <p:nvPr/>
          </p:nvSpPr>
          <p:spPr>
            <a:xfrm flipH="1">
              <a:off x="2840275" y="198492"/>
              <a:ext cx="3352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b="1" dirty="0"/>
                <a:t>      HC    DGJ   CHQ  G208H R342X</a:t>
              </a:r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00000000-0008-0000-0000-000009000000}"/>
                </a:ext>
              </a:extLst>
            </p:cNvPr>
            <p:cNvGrpSpPr/>
            <p:nvPr/>
          </p:nvGrpSpPr>
          <p:grpSpPr>
            <a:xfrm>
              <a:off x="4006539" y="-32145"/>
              <a:ext cx="631377" cy="307952"/>
              <a:chOff x="4006539" y="-32145"/>
              <a:chExt cx="631377" cy="307952"/>
            </a:xfrm>
          </p:grpSpPr>
          <p:sp>
            <p:nvSpPr>
              <p:cNvPr id="22" name="TextBox 76">
                <a:extLst>
                  <a:ext uri="{FF2B5EF4-FFF2-40B4-BE49-F238E27FC236}">
                    <a16:creationId xmlns:a16="http://schemas.microsoft.com/office/drawing/2014/main" id="{00000000-0008-0000-0000-000006000000}"/>
                  </a:ext>
                </a:extLst>
              </p:cNvPr>
              <p:cNvSpPr txBox="1"/>
              <p:nvPr/>
            </p:nvSpPr>
            <p:spPr>
              <a:xfrm>
                <a:off x="4006539" y="-32145"/>
                <a:ext cx="27041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200" b="1" dirty="0">
                    <a:solidFill>
                      <a:srgbClr val="0070C0"/>
                    </a:solidFill>
                  </a:rPr>
                  <a:t>1</a:t>
                </a:r>
              </a:p>
            </p:txBody>
          </p:sp>
          <p:sp>
            <p:nvSpPr>
              <p:cNvPr id="23" name="TextBox 89">
                <a:extLst>
                  <a:ext uri="{FF2B5EF4-FFF2-40B4-BE49-F238E27FC236}">
                    <a16:creationId xmlns:a16="http://schemas.microsoft.com/office/drawing/2014/main" id="{00000000-0008-0000-0000-000007000000}"/>
                  </a:ext>
                </a:extLst>
              </p:cNvPr>
              <p:cNvSpPr txBox="1"/>
              <p:nvPr/>
            </p:nvSpPr>
            <p:spPr>
              <a:xfrm>
                <a:off x="4374702" y="-1192"/>
                <a:ext cx="26321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200" b="1" dirty="0">
                    <a:solidFill>
                      <a:srgbClr val="0070C0"/>
                    </a:solidFill>
                  </a:rPr>
                  <a:t>7</a:t>
                </a:r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CF30B8BB-292F-B382-DA94-9A7D1E50783C}"/>
              </a:ext>
            </a:extLst>
          </p:cNvPr>
          <p:cNvSpPr txBox="1"/>
          <p:nvPr/>
        </p:nvSpPr>
        <p:spPr>
          <a:xfrm>
            <a:off x="1337513" y="6464451"/>
            <a:ext cx="10326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1 (continues) Whole blots corresponding to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Galactosidase A quantification by WB</a:t>
            </a:r>
            <a:r>
              <a:rPr lang="en-GB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1806785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D8F164-9036-B30A-DCD7-0119650CA3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617EE6-70F4-CE96-03DE-E6FEED9E82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0A391D6-152B-B160-08A3-C162BC6D37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F99410B-C4BC-7812-4F67-515785E37582}"/>
              </a:ext>
            </a:extLst>
          </p:cNvPr>
          <p:cNvSpPr txBox="1"/>
          <p:nvPr/>
        </p:nvSpPr>
        <p:spPr>
          <a:xfrm>
            <a:off x="7794171" y="365125"/>
            <a:ext cx="24838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2.</a:t>
            </a:r>
          </a:p>
        </p:txBody>
      </p:sp>
    </p:spTree>
    <p:extLst>
      <p:ext uri="{BB962C8B-B14F-4D97-AF65-F5344CB8AC3E}">
        <p14:creationId xmlns:p14="http://schemas.microsoft.com/office/powerpoint/2010/main" val="398335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F04078-6D6B-1742-56D4-70203DF545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D9AC94-ABA0-6331-3AF5-74582512FA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3FBF112-D8CF-3966-BCBC-82BB9847F3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5BCB57E-2EF1-562E-E255-809F6F45CB89}"/>
              </a:ext>
            </a:extLst>
          </p:cNvPr>
          <p:cNvSpPr txBox="1"/>
          <p:nvPr/>
        </p:nvSpPr>
        <p:spPr>
          <a:xfrm>
            <a:off x="145142" y="45522"/>
            <a:ext cx="24838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3.</a:t>
            </a:r>
          </a:p>
        </p:txBody>
      </p:sp>
    </p:spTree>
    <p:extLst>
      <p:ext uri="{BB962C8B-B14F-4D97-AF65-F5344CB8AC3E}">
        <p14:creationId xmlns:p14="http://schemas.microsoft.com/office/powerpoint/2010/main" val="29143283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1368489-75BA-EF1A-3450-3057880910E5}"/>
              </a:ext>
            </a:extLst>
          </p:cNvPr>
          <p:cNvSpPr txBox="1"/>
          <p:nvPr/>
        </p:nvSpPr>
        <p:spPr>
          <a:xfrm>
            <a:off x="59108" y="31048"/>
            <a:ext cx="113777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/>
              <a:t>Supplementary fig. 4. Relation between total </a:t>
            </a:r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-galactosidase A protein by western blot and α-galactosidase A activity. </a:t>
            </a:r>
            <a:endParaRPr lang="en-GB" sz="1400" b="1" dirty="0"/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5193061A-CAEA-99BB-D896-49A57FDBF74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863" y="776288"/>
          <a:ext cx="6189662" cy="61896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7949276" imgH="7954002" progId="Prism8.Document">
                  <p:embed/>
                </p:oleObj>
              </mc:Choice>
              <mc:Fallback>
                <p:oleObj name="Prism 8" r:id="rId3" imgW="7949276" imgH="7954002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5193061A-CAEA-99BB-D896-49A57FDBF74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863" y="776288"/>
                        <a:ext cx="6189662" cy="61896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598C53F8-1656-5AE8-FF70-7371D4FDD41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180138" y="777875"/>
          <a:ext cx="6015037" cy="6186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7734275" imgH="7958684" progId="Prism8.Document">
                  <p:embed/>
                </p:oleObj>
              </mc:Choice>
              <mc:Fallback>
                <p:oleObj name="Prism 8" r:id="rId5" imgW="7734275" imgH="7958684" progId="Prism8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598C53F8-1656-5AE8-FF70-7371D4FDD4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180138" y="777875"/>
                        <a:ext cx="6015037" cy="6186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0671ADD4-3780-8B36-912C-BFAEA45476AA}"/>
              </a:ext>
            </a:extLst>
          </p:cNvPr>
          <p:cNvCxnSpPr/>
          <p:nvPr/>
        </p:nvCxnSpPr>
        <p:spPr>
          <a:xfrm>
            <a:off x="1548677" y="826139"/>
            <a:ext cx="288834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408DC087-0964-1A8E-479E-5DFBAEAC96CC}"/>
              </a:ext>
            </a:extLst>
          </p:cNvPr>
          <p:cNvCxnSpPr/>
          <p:nvPr/>
        </p:nvCxnSpPr>
        <p:spPr>
          <a:xfrm>
            <a:off x="8150508" y="818882"/>
            <a:ext cx="288834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CAE31AAC-4F3A-4BF9-CA23-5862FCED4D8D}"/>
              </a:ext>
            </a:extLst>
          </p:cNvPr>
          <p:cNvSpPr txBox="1"/>
          <p:nvPr/>
        </p:nvSpPr>
        <p:spPr>
          <a:xfrm>
            <a:off x="9111309" y="519294"/>
            <a:ext cx="9667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emale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A380F61-BDB8-E40C-CD85-09F4E718C831}"/>
              </a:ext>
            </a:extLst>
          </p:cNvPr>
          <p:cNvSpPr txBox="1"/>
          <p:nvPr/>
        </p:nvSpPr>
        <p:spPr>
          <a:xfrm>
            <a:off x="2519665" y="522883"/>
            <a:ext cx="763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Males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9E44F5DF-6E79-F33A-5535-940DDBB006E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472264" y="4072909"/>
          <a:ext cx="3275719" cy="22600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3873980" imgH="2671263" progId="Prism8.Document">
                  <p:embed/>
                </p:oleObj>
              </mc:Choice>
              <mc:Fallback>
                <p:oleObj name="Prism 8" r:id="rId7" imgW="3873980" imgH="2671263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9E44F5DF-6E79-F33A-5535-940DDBB006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472264" y="4072909"/>
                        <a:ext cx="3275719" cy="2260071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72F8E59B-610E-2694-0BD6-5AE08120BB7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587139" y="4116031"/>
          <a:ext cx="3274709" cy="22169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3947087" imgH="2671263" progId="Prism8.Document">
                  <p:embed/>
                </p:oleObj>
              </mc:Choice>
              <mc:Fallback>
                <p:oleObj name="Prism 8" r:id="rId9" imgW="3947087" imgH="2671263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72F8E59B-610E-2694-0BD6-5AE08120BB7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587139" y="4116031"/>
                        <a:ext cx="3274709" cy="2216949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600781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F0FEF8ED-7C27-E3A6-1784-A64540219A06}"/>
              </a:ext>
            </a:extLst>
          </p:cNvPr>
          <p:cNvSpPr txBox="1"/>
          <p:nvPr/>
        </p:nvSpPr>
        <p:spPr>
          <a:xfrm>
            <a:off x="1632516" y="135441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90A10DF4-6AB7-B2C3-E797-60DE073845A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268123" y="1433867"/>
          <a:ext cx="2852738" cy="3240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556603" imgH="2901401" progId="Prism8.Document">
                  <p:embed/>
                </p:oleObj>
              </mc:Choice>
              <mc:Fallback>
                <p:oleObj name="Prism 8" r:id="rId2" imgW="2556603" imgH="2901401" progId="Prism8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90A10DF4-6AB7-B2C3-E797-60DE073845A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268123" y="1433867"/>
                        <a:ext cx="2852738" cy="3240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2E96877E-ED29-FAAA-8A50-60B45419E371}"/>
              </a:ext>
            </a:extLst>
          </p:cNvPr>
          <p:cNvSpPr txBox="1"/>
          <p:nvPr/>
        </p:nvSpPr>
        <p:spPr>
          <a:xfrm>
            <a:off x="0" y="-30579"/>
            <a:ext cx="12191999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b="1" dirty="0"/>
              <a:t>Supplementary Fig. 5. (A) Total levels of plasma lyso-Gb3 and (B) correlation analysis between biochemical and clinical outcomes for females and (C) for males. </a:t>
            </a:r>
            <a:r>
              <a:rPr lang="en-GB" dirty="0"/>
              <a:t>Lyso-Gb3 data was only available for 16 males and 8 females. In </a:t>
            </a:r>
            <a:r>
              <a:rPr lang="en-GB" b="1" dirty="0">
                <a:solidFill>
                  <a:schemeClr val="accent2"/>
                </a:solidFill>
              </a:rPr>
              <a:t>orange</a:t>
            </a:r>
            <a:r>
              <a:rPr lang="en-GB" dirty="0"/>
              <a:t> are patients who were on treatment at the time the biomarker was measured (8 males and 5 females). In </a:t>
            </a:r>
            <a:r>
              <a:rPr lang="en-GB" b="1" dirty="0">
                <a:solidFill>
                  <a:srgbClr val="FF0000"/>
                </a:solidFill>
              </a:rPr>
              <a:t>red </a:t>
            </a:r>
            <a:r>
              <a:rPr lang="en-GB" dirty="0"/>
              <a:t>are those subjects with the N215S genotype.</a:t>
            </a:r>
          </a:p>
          <a:p>
            <a:pPr algn="just"/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2702825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7C1661D-F40E-DE59-085E-0ED16E83C78D}"/>
              </a:ext>
            </a:extLst>
          </p:cNvPr>
          <p:cNvSpPr txBox="1"/>
          <p:nvPr/>
        </p:nvSpPr>
        <p:spPr>
          <a:xfrm>
            <a:off x="0" y="-30579"/>
            <a:ext cx="12191999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b="1" dirty="0"/>
              <a:t>Supplementary Fig. 5. (A) Total levels of plasma lyso-Gb3 and (B) correlation analysis between biochemical and clinical outcomes for females and (C) for males. </a:t>
            </a:r>
            <a:r>
              <a:rPr lang="en-GB" dirty="0"/>
              <a:t>Lyso-Gb3 data was only available for 16 males and 8 females. In </a:t>
            </a:r>
            <a:r>
              <a:rPr lang="en-GB" b="1" dirty="0">
                <a:solidFill>
                  <a:schemeClr val="accent2"/>
                </a:solidFill>
              </a:rPr>
              <a:t>orange</a:t>
            </a:r>
            <a:r>
              <a:rPr lang="en-GB" dirty="0"/>
              <a:t> are patients who were on treatment at the time the biomarker was measured (8 males and 5 females). In </a:t>
            </a:r>
            <a:r>
              <a:rPr lang="en-GB" b="1" dirty="0">
                <a:solidFill>
                  <a:srgbClr val="FF0000"/>
                </a:solidFill>
              </a:rPr>
              <a:t>red </a:t>
            </a:r>
            <a:r>
              <a:rPr lang="en-GB" dirty="0"/>
              <a:t>are those subjects with the N215S genotype.</a:t>
            </a:r>
          </a:p>
          <a:p>
            <a:pPr algn="just"/>
            <a:endParaRPr lang="en-GB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0FEF8ED-7C27-E3A6-1784-A64540219A06}"/>
              </a:ext>
            </a:extLst>
          </p:cNvPr>
          <p:cNvSpPr txBox="1"/>
          <p:nvPr/>
        </p:nvSpPr>
        <p:spPr>
          <a:xfrm>
            <a:off x="99539" y="107349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F3D8DCEE-2B35-3BFF-1E3B-CFA889588D1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-113625" y="1354416"/>
          <a:ext cx="4121650" cy="29122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819239" imgH="2698634" progId="Prism8.Document">
                  <p:embed/>
                </p:oleObj>
              </mc:Choice>
              <mc:Fallback>
                <p:oleObj name="Prism 8" r:id="rId2" imgW="3819239" imgH="2698634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F3D8DCEE-2B35-3BFF-1E3B-CFA889588D1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-113625" y="1354416"/>
                        <a:ext cx="4121650" cy="29122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47D76AF6-FF9F-81DF-AB1D-72E52E740AA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320674" y="4102767"/>
          <a:ext cx="3983038" cy="2900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691031" imgH="2689630" progId="Prism8.Document">
                  <p:embed/>
                </p:oleObj>
              </mc:Choice>
              <mc:Fallback>
                <p:oleObj name="Prism 8" r:id="rId4" imgW="3691031" imgH="2689630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47D76AF6-FF9F-81DF-AB1D-72E52E740A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320674" y="4102767"/>
                        <a:ext cx="3983038" cy="2900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28FF1F17-2373-C75D-8126-AAA19D73262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881596" y="4138864"/>
          <a:ext cx="4121650" cy="2866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887665" imgH="2703316" progId="Prism8.Document">
                  <p:embed/>
                </p:oleObj>
              </mc:Choice>
              <mc:Fallback>
                <p:oleObj name="Prism 8" r:id="rId6" imgW="3887665" imgH="2703316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28FF1F17-2373-C75D-8126-AAA19D7326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881596" y="4138864"/>
                        <a:ext cx="4121650" cy="2866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CB511B2B-ABD5-0977-3E86-D2B57EA7D95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302334" y="1353906"/>
          <a:ext cx="3983038" cy="2900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691031" imgH="2689630" progId="Prism8.Document">
                  <p:embed/>
                </p:oleObj>
              </mc:Choice>
              <mc:Fallback>
                <p:oleObj name="Prism 8" r:id="rId8" imgW="3691031" imgH="2689630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CB511B2B-ABD5-0977-3E86-D2B57EA7D9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302334" y="1353906"/>
                        <a:ext cx="3983038" cy="2900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97CABB6C-DEAA-35D8-52CF-BBE84C67BA0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859294" y="1390688"/>
          <a:ext cx="4121650" cy="2866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3887665" imgH="2703316" progId="Prism8.Document">
                  <p:embed/>
                </p:oleObj>
              </mc:Choice>
              <mc:Fallback>
                <p:oleObj name="Prism 8" r:id="rId10" imgW="3887665" imgH="2703316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97CABB6C-DEAA-35D8-52CF-BBE84C67BA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859294" y="1390688"/>
                        <a:ext cx="4121650" cy="2866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3C0EA45C-FBC6-32C1-2E26-7051D5A2FEF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-48424" y="4102941"/>
          <a:ext cx="4121650" cy="29122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3819239" imgH="2698634" progId="Prism8.Document">
                  <p:embed/>
                </p:oleObj>
              </mc:Choice>
              <mc:Fallback>
                <p:oleObj name="Prism 8" r:id="rId12" imgW="3819239" imgH="2698634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3C0EA45C-FBC6-32C1-2E26-7051D5A2FE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-48424" y="4102941"/>
                        <a:ext cx="4121650" cy="29122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557584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F0FEF8ED-7C27-E3A6-1784-A64540219A06}"/>
              </a:ext>
            </a:extLst>
          </p:cNvPr>
          <p:cNvSpPr txBox="1"/>
          <p:nvPr/>
        </p:nvSpPr>
        <p:spPr>
          <a:xfrm>
            <a:off x="1632516" y="135441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E96877E-ED29-FAAA-8A50-60B45419E371}"/>
              </a:ext>
            </a:extLst>
          </p:cNvPr>
          <p:cNvSpPr txBox="1"/>
          <p:nvPr/>
        </p:nvSpPr>
        <p:spPr>
          <a:xfrm>
            <a:off x="0" y="-30579"/>
            <a:ext cx="12191999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b="1" dirty="0"/>
              <a:t>Supplementary Fig. 5. (A) Total levels of plasma lyso-Gb3 and (B) correlation analysis between biochemical and clinical outcomes for females and (C) for males. </a:t>
            </a:r>
            <a:r>
              <a:rPr lang="en-GB" dirty="0"/>
              <a:t>Lyso-Gb3 data was only available for 16 males and 8 females. In </a:t>
            </a:r>
            <a:r>
              <a:rPr lang="en-GB" b="1" dirty="0">
                <a:solidFill>
                  <a:schemeClr val="accent2"/>
                </a:solidFill>
              </a:rPr>
              <a:t>orange</a:t>
            </a:r>
            <a:r>
              <a:rPr lang="en-GB" dirty="0"/>
              <a:t> are patients who were on treatment at the time the biomarker was measured (8 males and 5 females). In </a:t>
            </a:r>
            <a:r>
              <a:rPr lang="en-GB" b="1" dirty="0">
                <a:solidFill>
                  <a:srgbClr val="FF0000"/>
                </a:solidFill>
              </a:rPr>
              <a:t>red </a:t>
            </a:r>
            <a:r>
              <a:rPr lang="en-GB" dirty="0"/>
              <a:t>are those subjects with the N215S genotype.</a:t>
            </a:r>
          </a:p>
          <a:p>
            <a:pPr algn="just"/>
            <a:endParaRPr lang="en-GB" b="1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F375D20-E0F2-5E61-1E93-4B492DE9FC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2335" y="1866200"/>
            <a:ext cx="4384675" cy="31255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4668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98</Words>
  <Application>Microsoft Macintosh PowerPoint</Application>
  <PresentationFormat>Widescreen</PresentationFormat>
  <Paragraphs>31</Paragraphs>
  <Slides>8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ptos</vt:lpstr>
      <vt:lpstr>Aptos Display</vt:lpstr>
      <vt:lpstr>Arial</vt:lpstr>
      <vt:lpstr>Calibri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ucia Lavalle</dc:creator>
  <cp:lastModifiedBy>Lucia Lavalle</cp:lastModifiedBy>
  <cp:revision>2</cp:revision>
  <dcterms:created xsi:type="dcterms:W3CDTF">2025-09-16T14:34:36Z</dcterms:created>
  <dcterms:modified xsi:type="dcterms:W3CDTF">2025-09-16T14:37:05Z</dcterms:modified>
</cp:coreProperties>
</file>